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84" r:id="rId1"/>
  </p:sldMasterIdLst>
  <p:notesMasterIdLst>
    <p:notesMasterId r:id="rId5"/>
  </p:notesMasterIdLst>
  <p:sldIdLst>
    <p:sldId id="365" r:id="rId2"/>
    <p:sldId id="367" r:id="rId3"/>
    <p:sldId id="366" r:id="rId4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3629911-B08E-B3FD-B780-85C9BCBD3DEA}" name="sakamoto ken" initials="sk" userId="6812a7c0f796937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EBF5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82" autoAdjust="0"/>
    <p:restoredTop sz="93447" autoAdjust="0"/>
  </p:normalViewPr>
  <p:slideViewPr>
    <p:cSldViewPr snapToGrid="0">
      <p:cViewPr>
        <p:scale>
          <a:sx n="66" d="100"/>
          <a:sy n="66" d="100"/>
        </p:scale>
        <p:origin x="83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B4031D-58B3-4561-8F52-1BA24B8D2CE4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C2DF90-B64D-4B5C-BF72-C3938CF900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4683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91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583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914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166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263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6346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567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5766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952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3086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300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3D76A-F6DE-465F-8FEB-DDD5789E6DA5}" type="datetimeFigureOut">
              <a:rPr kumimoji="1" lang="ja-JP" altLang="en-US" smtClean="0"/>
              <a:t>2023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8F03F-3E79-4C6A-8181-CFD9EB1FC3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428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図 98">
            <a:extLst>
              <a:ext uri="{FF2B5EF4-FFF2-40B4-BE49-F238E27FC236}">
                <a16:creationId xmlns:a16="http://schemas.microsoft.com/office/drawing/2014/main" id="{4CB781D3-C93C-A268-A772-87D9FDCE70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3734" y="11123927"/>
            <a:ext cx="5897034" cy="2205086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DA5D550A-4B56-2F2B-1B05-A781279FC5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0118" y="8815897"/>
            <a:ext cx="5893704" cy="2190766"/>
          </a:xfrm>
          <a:prstGeom prst="rect">
            <a:avLst/>
          </a:prstGeom>
        </p:spPr>
      </p:pic>
      <p:pic>
        <p:nvPicPr>
          <p:cNvPr id="95" name="図 94">
            <a:extLst>
              <a:ext uri="{FF2B5EF4-FFF2-40B4-BE49-F238E27FC236}">
                <a16:creationId xmlns:a16="http://schemas.microsoft.com/office/drawing/2014/main" id="{0F0320DD-B8C4-B446-94BD-866F40E6DD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64691" y="6460072"/>
            <a:ext cx="5896075" cy="2212079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171232C5-FA2A-96C1-C8DB-ECCF81B35A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63733" y="4153971"/>
            <a:ext cx="5892800" cy="2194128"/>
          </a:xfrm>
          <a:prstGeom prst="rect">
            <a:avLst/>
          </a:prstGeom>
        </p:spPr>
      </p:pic>
      <p:pic>
        <p:nvPicPr>
          <p:cNvPr id="89" name="図 88">
            <a:extLst>
              <a:ext uri="{FF2B5EF4-FFF2-40B4-BE49-F238E27FC236}">
                <a16:creationId xmlns:a16="http://schemas.microsoft.com/office/drawing/2014/main" id="{C61082DF-8B79-C4D3-4B0A-698A474D52C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57003" y="1816105"/>
            <a:ext cx="5906159" cy="2202225"/>
          </a:xfrm>
          <a:prstGeom prst="rect">
            <a:avLst/>
          </a:prstGeom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1EA98931-8C6B-CFA9-BF77-CF3B8C1C25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2766" y="11125988"/>
            <a:ext cx="5901267" cy="2200401"/>
          </a:xfrm>
          <a:prstGeom prst="rect">
            <a:avLst/>
          </a:prstGeom>
        </p:spPr>
      </p:pic>
      <p:pic>
        <p:nvPicPr>
          <p:cNvPr id="85" name="図 84">
            <a:extLst>
              <a:ext uri="{FF2B5EF4-FFF2-40B4-BE49-F238E27FC236}">
                <a16:creationId xmlns:a16="http://schemas.microsoft.com/office/drawing/2014/main" id="{D432C27E-7ACD-388C-0B48-5392962D12B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8533" y="8804455"/>
            <a:ext cx="5897033" cy="2203011"/>
          </a:xfrm>
          <a:prstGeom prst="rect">
            <a:avLst/>
          </a:prstGeom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id="{4BF80E4E-4091-F550-1DFF-289B336BBDE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2589" y="6477503"/>
            <a:ext cx="5907212" cy="2191114"/>
          </a:xfrm>
          <a:prstGeom prst="rect">
            <a:avLst/>
          </a:prstGeom>
        </p:spPr>
      </p:pic>
      <p:pic>
        <p:nvPicPr>
          <p:cNvPr id="81" name="図 80">
            <a:extLst>
              <a:ext uri="{FF2B5EF4-FFF2-40B4-BE49-F238E27FC236}">
                <a16:creationId xmlns:a16="http://schemas.microsoft.com/office/drawing/2014/main" id="{03B880C7-C2CB-8123-0023-BB80C0F342C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7163" y="4145279"/>
            <a:ext cx="5902637" cy="2205611"/>
          </a:xfrm>
          <a:prstGeom prst="rect">
            <a:avLst/>
          </a:prstGeom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D7A5420B-23F1-15EC-DD79-B6A73649CC2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2766" y="1811867"/>
            <a:ext cx="5888212" cy="2191840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C53E78F5-F5BB-CBB1-39F9-9CAAFB84F458}"/>
                  </a:ext>
                </a:extLst>
              </p:cNvPr>
              <p:cNvSpPr/>
              <p:nvPr/>
            </p:nvSpPr>
            <p:spPr>
              <a:xfrm>
                <a:off x="215444" y="173722"/>
                <a:ext cx="10007463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1 (Sensitivity analysis of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altLang="ja-JP" sz="200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altLang="ja-JP" sz="20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𝑃</m:t>
                        </m:r>
                      </m:e>
                      <m:sub>
                        <m:r>
                          <a:rPr lang="en-US" altLang="ja-JP" sz="20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𝐼𝑀𝑃𝑂𝑅𝑇</m:t>
                        </m:r>
                      </m:sub>
                    </m:sSub>
                  </m:oMath>
                </a14:m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14:m>
                  <m:oMath xmlns:m="http://schemas.openxmlformats.org/officeDocument/2006/math">
                    <m:r>
                      <a:rPr lang="en-US" altLang="ja-JP" sz="2000" b="0" i="1" smtClean="0">
                        <a:latin typeface="Cambria Math" panose="02040503050406030204" pitchFamily="18" charset="0"/>
                        <a:cs typeface="Times New Roman" panose="02020603050405020304" pitchFamily="18" charset="0"/>
                      </a:rPr>
                      <m:t>𝐷</m:t>
                    </m:r>
                  </m:oMath>
                </a14:m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7 days [SD 1 day])</a:t>
                </a:r>
                <a:endParaRPr lang="ja-JP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C53E78F5-F5BB-CBB1-39F9-9CAAFB84F458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5444" y="173722"/>
                <a:ext cx="10007463" cy="400110"/>
              </a:xfrm>
              <a:prstGeom prst="rect">
                <a:avLst/>
              </a:prstGeom>
              <a:blipFill>
                <a:blip r:embed="rId12"/>
                <a:stretch>
                  <a:fillRect l="-609" t="-7576" b="-25758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4ED0818E-1FF9-11EC-538C-04B942018D0E}"/>
              </a:ext>
            </a:extLst>
          </p:cNvPr>
          <p:cNvGrpSpPr/>
          <p:nvPr/>
        </p:nvGrpSpPr>
        <p:grpSpPr>
          <a:xfrm>
            <a:off x="-42531" y="2752498"/>
            <a:ext cx="10265438" cy="9946895"/>
            <a:chOff x="-42531" y="2752498"/>
            <a:chExt cx="10265438" cy="9946895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6C880B7E-9465-94FE-80ED-510F68B14A6C}"/>
                </a:ext>
              </a:extLst>
            </p:cNvPr>
            <p:cNvGrpSpPr/>
            <p:nvPr/>
          </p:nvGrpSpPr>
          <p:grpSpPr>
            <a:xfrm>
              <a:off x="-42531" y="2752498"/>
              <a:ext cx="10265438" cy="641523"/>
              <a:chOff x="-42531" y="2752498"/>
              <a:chExt cx="10265438" cy="641523"/>
            </a:xfrm>
          </p:grpSpPr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64816096-4E54-515F-3E58-188E05D8E4BE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734E3107-9BF3-6071-FB6B-6E5C9A597B14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4DD10E28-7EE1-983C-0DB4-31D890A2B2A8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D1B473C9-8C80-574C-4170-B718C18D3A1E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860599A2-92F8-4730-D5A7-8E6AE583BCFB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676C3CAF-8CF5-BE36-0F9B-E38F69D0F8F0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E177F542-97C8-B2F0-5B09-5D193432F8D6}"/>
                </a:ext>
              </a:extLst>
            </p:cNvPr>
            <p:cNvGrpSpPr/>
            <p:nvPr/>
          </p:nvGrpSpPr>
          <p:grpSpPr>
            <a:xfrm>
              <a:off x="-42531" y="5063898"/>
              <a:ext cx="10265438" cy="641523"/>
              <a:chOff x="-42531" y="2752498"/>
              <a:chExt cx="10265438" cy="641523"/>
            </a:xfrm>
          </p:grpSpPr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A45E2B11-3525-1E93-99BE-A2A83415C91E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9A5A7684-B686-2616-63F3-8F154CDDB269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2F1C5218-5143-6DE7-3C78-65B24B5CF80F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4BB51805-5950-DF1D-8436-1C192C298FEF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CA43F204-E8F3-DAE3-3EC8-A567957A19F5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0B9A17F1-0B19-9056-1959-32D9752EC0A2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38217D0B-A4BB-037C-2497-90553FAA41E6}"/>
                </a:ext>
              </a:extLst>
            </p:cNvPr>
            <p:cNvGrpSpPr/>
            <p:nvPr/>
          </p:nvGrpSpPr>
          <p:grpSpPr>
            <a:xfrm>
              <a:off x="-42531" y="7389700"/>
              <a:ext cx="10265438" cy="641523"/>
              <a:chOff x="-42531" y="2752498"/>
              <a:chExt cx="10265438" cy="641523"/>
            </a:xfrm>
          </p:grpSpPr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EC110D09-EAC2-57D0-FDA4-31C289A7DCB2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E2B3E9A9-D8E2-C483-F6D0-24AC0BF3D572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F3C495ED-D061-A616-3408-6218F3D9E5E1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3706E675-1068-7117-A71B-66B9BFD3B26F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2F01F7A3-ABF4-FA2B-EC47-3E2011AD8C07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B8DAFE6D-0A3A-7853-02DD-89691538D860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3DDEED0A-385F-42B8-52AE-93C2B4C80919}"/>
                </a:ext>
              </a:extLst>
            </p:cNvPr>
            <p:cNvGrpSpPr/>
            <p:nvPr/>
          </p:nvGrpSpPr>
          <p:grpSpPr>
            <a:xfrm>
              <a:off x="-42531" y="9727861"/>
              <a:ext cx="10265438" cy="641523"/>
              <a:chOff x="-42531" y="2752498"/>
              <a:chExt cx="10265438" cy="641523"/>
            </a:xfrm>
          </p:grpSpPr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81DDF477-DEBC-90C7-8D12-D011C3111C95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BC6BB8C9-79D2-4401-87D1-785354FA4C9C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13CCB2B4-5C2F-09BC-12A3-AAAB32C9E020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6323625E-4951-057B-3E1A-905E19189EBF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2BD4CFA1-F413-8DA5-B194-E4EBF88E3F97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DE06126F-765B-F81C-39B8-D660B95B0D98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C362D226-3A15-B6ED-BC41-75041218A5FA}"/>
                </a:ext>
              </a:extLst>
            </p:cNvPr>
            <p:cNvGrpSpPr/>
            <p:nvPr/>
          </p:nvGrpSpPr>
          <p:grpSpPr>
            <a:xfrm>
              <a:off x="-42531" y="12057870"/>
              <a:ext cx="10265438" cy="641523"/>
              <a:chOff x="-42531" y="2752498"/>
              <a:chExt cx="10265438" cy="641523"/>
            </a:xfrm>
          </p:grpSpPr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B0ACA603-2F55-F109-9F55-8F06DED01339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661B7686-C84F-55F9-4A1E-12D0D75DD193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1DD26F31-68D9-EA46-8C64-AB5EC4AF377B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6FFE6155-F0FB-39F7-3C39-8A5BE54C0409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307EE3CA-5B60-1B8E-EAC3-C7733D561ECE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7176F7E9-55E4-691C-EC8B-E1EF575C3D74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82580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図 75">
            <a:extLst>
              <a:ext uri="{FF2B5EF4-FFF2-40B4-BE49-F238E27FC236}">
                <a16:creationId xmlns:a16="http://schemas.microsoft.com/office/drawing/2014/main" id="{4DCF6288-A624-B0B7-E8BB-F079FDE50F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2151" y="11128519"/>
            <a:ext cx="5907816" cy="2186197"/>
          </a:xfrm>
          <a:prstGeom prst="rect">
            <a:avLst/>
          </a:prstGeom>
        </p:spPr>
      </p:pic>
      <p:pic>
        <p:nvPicPr>
          <p:cNvPr id="74" name="図 73">
            <a:extLst>
              <a:ext uri="{FF2B5EF4-FFF2-40B4-BE49-F238E27FC236}">
                <a16:creationId xmlns:a16="http://schemas.microsoft.com/office/drawing/2014/main" id="{B542C8A3-A308-3370-2854-0741825C84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9499" y="8813800"/>
            <a:ext cx="5903297" cy="2197281"/>
          </a:xfrm>
          <a:prstGeom prst="rect">
            <a:avLst/>
          </a:prstGeom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B273E9F4-0B06-E984-FE7A-76474F4988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0450" y="6470950"/>
            <a:ext cx="5938310" cy="2203331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0CB07D20-68E6-62DE-EAB0-CBCE637F91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60734" y="4158082"/>
            <a:ext cx="5897916" cy="2192101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B137F977-2E9F-200C-4B3A-95C9C7562A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59500" y="1817172"/>
            <a:ext cx="5889777" cy="2194727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0F24CD0E-2D82-B743-127D-099342BA55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3844" y="11119081"/>
            <a:ext cx="5906459" cy="2197162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E4890550-E334-56BE-D6E8-E2D329C05B4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4821" y="8815415"/>
            <a:ext cx="5916850" cy="2194059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423833E3-6242-4E67-0B36-E46FF7A176C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7000" y="6472414"/>
            <a:ext cx="5888564" cy="2196166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288234A4-6462-A401-2367-670A56CB5C0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2590" y="4125504"/>
            <a:ext cx="5911444" cy="2212351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7AD256B7-7859-1EA3-DC4A-9DE240C6069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7000" y="1796061"/>
            <a:ext cx="5899150" cy="2217878"/>
          </a:xfrm>
          <a:prstGeom prst="rect">
            <a:avLst/>
          </a:prstGeom>
        </p:spPr>
      </p:pic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4ED0818E-1FF9-11EC-538C-04B942018D0E}"/>
              </a:ext>
            </a:extLst>
          </p:cNvPr>
          <p:cNvGrpSpPr/>
          <p:nvPr/>
        </p:nvGrpSpPr>
        <p:grpSpPr>
          <a:xfrm>
            <a:off x="-42531" y="2752498"/>
            <a:ext cx="10265438" cy="9946895"/>
            <a:chOff x="-42531" y="2752498"/>
            <a:chExt cx="10265438" cy="9946895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6C880B7E-9465-94FE-80ED-510F68B14A6C}"/>
                </a:ext>
              </a:extLst>
            </p:cNvPr>
            <p:cNvGrpSpPr/>
            <p:nvPr/>
          </p:nvGrpSpPr>
          <p:grpSpPr>
            <a:xfrm>
              <a:off x="-42531" y="2752498"/>
              <a:ext cx="10265438" cy="641523"/>
              <a:chOff x="-42531" y="2752498"/>
              <a:chExt cx="10265438" cy="641523"/>
            </a:xfrm>
          </p:grpSpPr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64816096-4E54-515F-3E58-188E05D8E4BE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734E3107-9BF3-6071-FB6B-6E5C9A597B14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4DD10E28-7EE1-983C-0DB4-31D890A2B2A8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D1B473C9-8C80-574C-4170-B718C18D3A1E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860599A2-92F8-4730-D5A7-8E6AE583BCFB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676C3CAF-8CF5-BE36-0F9B-E38F69D0F8F0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E177F542-97C8-B2F0-5B09-5D193432F8D6}"/>
                </a:ext>
              </a:extLst>
            </p:cNvPr>
            <p:cNvGrpSpPr/>
            <p:nvPr/>
          </p:nvGrpSpPr>
          <p:grpSpPr>
            <a:xfrm>
              <a:off x="-42531" y="5063898"/>
              <a:ext cx="10265438" cy="641523"/>
              <a:chOff x="-42531" y="2752498"/>
              <a:chExt cx="10265438" cy="641523"/>
            </a:xfrm>
          </p:grpSpPr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A45E2B11-3525-1E93-99BE-A2A83415C91E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9A5A7684-B686-2616-63F3-8F154CDDB269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2F1C5218-5143-6DE7-3C78-65B24B5CF80F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4BB51805-5950-DF1D-8436-1C192C298FEF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CA43F204-E8F3-DAE3-3EC8-A567957A19F5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0B9A17F1-0B19-9056-1959-32D9752EC0A2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38217D0B-A4BB-037C-2497-90553FAA41E6}"/>
                </a:ext>
              </a:extLst>
            </p:cNvPr>
            <p:cNvGrpSpPr/>
            <p:nvPr/>
          </p:nvGrpSpPr>
          <p:grpSpPr>
            <a:xfrm>
              <a:off x="-42531" y="7389700"/>
              <a:ext cx="10265438" cy="641523"/>
              <a:chOff x="-42531" y="2752498"/>
              <a:chExt cx="10265438" cy="641523"/>
            </a:xfrm>
          </p:grpSpPr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EC110D09-EAC2-57D0-FDA4-31C289A7DCB2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E2B3E9A9-D8E2-C483-F6D0-24AC0BF3D572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F3C495ED-D061-A616-3408-6218F3D9E5E1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3706E675-1068-7117-A71B-66B9BFD3B26F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2F01F7A3-ABF4-FA2B-EC47-3E2011AD8C07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B8DAFE6D-0A3A-7853-02DD-89691538D860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3DDEED0A-385F-42B8-52AE-93C2B4C80919}"/>
                </a:ext>
              </a:extLst>
            </p:cNvPr>
            <p:cNvGrpSpPr/>
            <p:nvPr/>
          </p:nvGrpSpPr>
          <p:grpSpPr>
            <a:xfrm>
              <a:off x="-42531" y="9727861"/>
              <a:ext cx="10265438" cy="641523"/>
              <a:chOff x="-42531" y="2752498"/>
              <a:chExt cx="10265438" cy="641523"/>
            </a:xfrm>
          </p:grpSpPr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81DDF477-DEBC-90C7-8D12-D011C3111C95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BC6BB8C9-79D2-4401-87D1-785354FA4C9C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13CCB2B4-5C2F-09BC-12A3-AAAB32C9E020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6323625E-4951-057B-3E1A-905E19189EBF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2BD4CFA1-F413-8DA5-B194-E4EBF88E3F97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DE06126F-765B-F81C-39B8-D660B95B0D98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C362D226-3A15-B6ED-BC41-75041218A5FA}"/>
                </a:ext>
              </a:extLst>
            </p:cNvPr>
            <p:cNvGrpSpPr/>
            <p:nvPr/>
          </p:nvGrpSpPr>
          <p:grpSpPr>
            <a:xfrm>
              <a:off x="-42531" y="12057870"/>
              <a:ext cx="10265438" cy="641523"/>
              <a:chOff x="-42531" y="2752498"/>
              <a:chExt cx="10265438" cy="641523"/>
            </a:xfrm>
          </p:grpSpPr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B0ACA603-2F55-F109-9F55-8F06DED01339}"/>
                  </a:ext>
                </a:extLst>
              </p:cNvPr>
              <p:cNvSpPr txBox="1"/>
              <p:nvPr/>
            </p:nvSpPr>
            <p:spPr>
              <a:xfrm rot="16200000">
                <a:off x="-255570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661B7686-C84F-55F9-4A1E-12D0D75DD193}"/>
                  </a:ext>
                </a:extLst>
              </p:cNvPr>
              <p:cNvSpPr txBox="1"/>
              <p:nvPr/>
            </p:nvSpPr>
            <p:spPr>
              <a:xfrm rot="16200000">
                <a:off x="1763730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1DD26F31-68D9-EA46-8C64-AB5EC4AF377B}"/>
                  </a:ext>
                </a:extLst>
              </p:cNvPr>
              <p:cNvSpPr txBox="1"/>
              <p:nvPr/>
            </p:nvSpPr>
            <p:spPr>
              <a:xfrm rot="16200000">
                <a:off x="3754455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6FFE6155-F0FB-39F7-3C39-8A5BE54C0409}"/>
                  </a:ext>
                </a:extLst>
              </p:cNvPr>
              <p:cNvSpPr txBox="1"/>
              <p:nvPr/>
            </p:nvSpPr>
            <p:spPr>
              <a:xfrm rot="16200000">
                <a:off x="5779077" y="2965538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307EE3CA-5B60-1B8E-EAC3-C7733D561ECE}"/>
                  </a:ext>
                </a:extLst>
              </p:cNvPr>
              <p:cNvSpPr txBox="1"/>
              <p:nvPr/>
            </p:nvSpPr>
            <p:spPr>
              <a:xfrm rot="16200000">
                <a:off x="7789879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7176F7E9-55E4-691C-EC8B-E1EF575C3D74}"/>
                  </a:ext>
                </a:extLst>
              </p:cNvPr>
              <p:cNvSpPr txBox="1"/>
              <p:nvPr/>
            </p:nvSpPr>
            <p:spPr>
              <a:xfrm rot="16200000">
                <a:off x="9794424" y="2965537"/>
                <a:ext cx="6415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mc:AlternateContent xmlns:mc="http://schemas.openxmlformats.org/markup-compatibility/2006">
        <mc:Choice xmlns:a14="http://schemas.microsoft.com/office/drawing/2010/main" Requires="a14"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C53E78F5-F5BB-CBB1-39F9-9CAAFB84F458}"/>
                  </a:ext>
                </a:extLst>
              </p:cNvPr>
              <p:cNvSpPr/>
              <p:nvPr/>
            </p:nvSpPr>
            <p:spPr>
              <a:xfrm>
                <a:off x="215444" y="173722"/>
                <a:ext cx="10007463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2 (Sensitivity analysis of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altLang="ja-JP" sz="200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altLang="ja-JP" sz="20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𝑃</m:t>
                        </m:r>
                      </m:e>
                      <m:sub>
                        <m:r>
                          <a:rPr lang="en-US" altLang="ja-JP" sz="20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𝐼𝑀𝑃𝑂𝑅𝑇</m:t>
                        </m:r>
                      </m:sub>
                    </m:sSub>
                  </m:oMath>
                </a14:m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14:m>
                  <m:oMath xmlns:m="http://schemas.openxmlformats.org/officeDocument/2006/math">
                    <m:r>
                      <a:rPr lang="en-US" altLang="ja-JP" sz="2000" b="0" i="1" smtClean="0">
                        <a:latin typeface="Cambria Math" panose="02040503050406030204" pitchFamily="18" charset="0"/>
                        <a:cs typeface="Times New Roman" panose="02020603050405020304" pitchFamily="18" charset="0"/>
                      </a:rPr>
                      <m:t>𝐷</m:t>
                    </m:r>
                  </m:oMath>
                </a14:m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2 days [SD 1 day])</a:t>
                </a:r>
                <a:endParaRPr lang="ja-JP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C53E78F5-F5BB-CBB1-39F9-9CAAFB84F458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5444" y="173722"/>
                <a:ext cx="10007463" cy="400110"/>
              </a:xfrm>
              <a:prstGeom prst="rect">
                <a:avLst/>
              </a:prstGeom>
              <a:blipFill>
                <a:blip r:embed="rId12"/>
                <a:stretch>
                  <a:fillRect l="-609" t="-7576" b="-25758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924598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>
            <a:extLst>
              <a:ext uri="{FF2B5EF4-FFF2-40B4-BE49-F238E27FC236}">
                <a16:creationId xmlns:a16="http://schemas.microsoft.com/office/drawing/2014/main" id="{D526ACEC-8A22-E812-D51C-38AF1D0B6D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49281" y="12603286"/>
            <a:ext cx="4879651" cy="293562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1F6B7E75-C61C-5439-601E-6E8C971FF2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7375" y="9617125"/>
            <a:ext cx="4915445" cy="2957153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B1205DE2-945F-4C40-26BC-9CEE812A7C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43895" y="6664113"/>
            <a:ext cx="4888924" cy="2949083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63D0E9A5-20E3-A523-56A8-3BFA58FF3BF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43895" y="3711102"/>
            <a:ext cx="4875910" cy="2933369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5E86B559-2AB9-ECD7-396D-5C67EB2836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43894" y="753317"/>
            <a:ext cx="4875005" cy="2932824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A745F3A9-26A2-E4C6-17B6-32C1DB6445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5287" y="12591351"/>
            <a:ext cx="4880082" cy="2943749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FB1E0BE1-772A-EFC9-4EDA-C242C0477A9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6447" y="9627732"/>
            <a:ext cx="4880082" cy="2935879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EB56003E-D759-1FEF-E5CC-C820FBF5F1F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1804" y="6660205"/>
            <a:ext cx="4873565" cy="2931958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D4EBB9D9-1B91-F7FC-9986-D52EB5C3FBB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05287" y="3711102"/>
            <a:ext cx="4871242" cy="293056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10777F47-2AF9-B235-0144-2AA1C2D9B26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5287" y="758091"/>
            <a:ext cx="4871242" cy="2932824"/>
          </a:xfrm>
          <a:prstGeom prst="rect">
            <a:avLst/>
          </a:prstGeom>
        </p:spPr>
      </p:pic>
      <mc:AlternateContent xmlns:mc="http://schemas.openxmlformats.org/markup-compatibility/2006">
        <mc:Choice xmlns:a14="http://schemas.microsoft.com/office/drawing/2010/main" Requires="a14"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9DA30FE2-336D-DE6A-9A98-EC19E1E3D3C6}"/>
                  </a:ext>
                </a:extLst>
              </p:cNvPr>
              <p:cNvSpPr/>
              <p:nvPr/>
            </p:nvSpPr>
            <p:spPr>
              <a:xfrm>
                <a:off x="215444" y="173722"/>
                <a:ext cx="10007463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3 (Sensitivity analysis of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altLang="ja-JP" sz="200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altLang="ja-JP" sz="20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𝑃</m:t>
                        </m:r>
                      </m:e>
                      <m:sub>
                        <m:r>
                          <a:rPr lang="en-US" altLang="ja-JP" sz="20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𝐴𝑈𝑇𝑂</m:t>
                        </m:r>
                      </m:sub>
                    </m:sSub>
                  </m:oMath>
                </a14:m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n-US" altLang="ja-JP" sz="2000" i="1" dirty="0">
                        <a:latin typeface="Cambria Math" panose="02040503050406030204" pitchFamily="18" charset="0"/>
                        <a:cs typeface="Times New Roman" panose="02020603050405020304" pitchFamily="18" charset="0"/>
                      </a:rPr>
                      <m:t>φ</m:t>
                    </m:r>
                  </m:oMath>
                </a14:m>
                <a:r>
                  <a:rPr lang="en-US" altLang="ja-JP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0.4 [SD 0.2])</a:t>
                </a:r>
                <a:endParaRPr lang="ja-JP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9DA30FE2-336D-DE6A-9A98-EC19E1E3D3C6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5444" y="173722"/>
                <a:ext cx="10007463" cy="400110"/>
              </a:xfrm>
              <a:prstGeom prst="rect">
                <a:avLst/>
              </a:prstGeom>
              <a:blipFill>
                <a:blip r:embed="rId12"/>
                <a:stretch>
                  <a:fillRect l="-609" t="-7576" b="-25758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0338E58-BD9F-6108-F571-BC560E60D2EC}"/>
              </a:ext>
            </a:extLst>
          </p:cNvPr>
          <p:cNvGrpSpPr/>
          <p:nvPr/>
        </p:nvGrpSpPr>
        <p:grpSpPr>
          <a:xfrm>
            <a:off x="458513" y="1922479"/>
            <a:ext cx="277000" cy="12693810"/>
            <a:chOff x="458513" y="1922479"/>
            <a:chExt cx="277000" cy="12693810"/>
          </a:xfrm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51510B1D-0707-A4E6-8DE3-37081DBC0E9A}"/>
                </a:ext>
              </a:extLst>
            </p:cNvPr>
            <p:cNvSpPr txBox="1"/>
            <p:nvPr/>
          </p:nvSpPr>
          <p:spPr>
            <a:xfrm rot="16200000">
              <a:off x="161637" y="2219355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1A463DF6-6174-83B1-18F3-4B6EA76A4312}"/>
                </a:ext>
              </a:extLst>
            </p:cNvPr>
            <p:cNvSpPr txBox="1"/>
            <p:nvPr/>
          </p:nvSpPr>
          <p:spPr>
            <a:xfrm rot="16200000">
              <a:off x="161637" y="5175120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751B7761-FA5C-85BE-B0B5-0BDE3EFCCE71}"/>
                </a:ext>
              </a:extLst>
            </p:cNvPr>
            <p:cNvSpPr txBox="1"/>
            <p:nvPr/>
          </p:nvSpPr>
          <p:spPr>
            <a:xfrm rot="16200000">
              <a:off x="161638" y="8130885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9B933845-591B-C112-2A32-CEE571756272}"/>
                </a:ext>
              </a:extLst>
            </p:cNvPr>
            <p:cNvSpPr txBox="1"/>
            <p:nvPr/>
          </p:nvSpPr>
          <p:spPr>
            <a:xfrm rot="16200000">
              <a:off x="161638" y="11086650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FEF8C10B-BD47-3098-B01D-449874C69045}"/>
                </a:ext>
              </a:extLst>
            </p:cNvPr>
            <p:cNvSpPr txBox="1"/>
            <p:nvPr/>
          </p:nvSpPr>
          <p:spPr>
            <a:xfrm rot="16200000">
              <a:off x="161638" y="14042414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55232FA9-057E-0251-1039-7D83966ADADF}"/>
              </a:ext>
            </a:extLst>
          </p:cNvPr>
          <p:cNvGrpSpPr/>
          <p:nvPr/>
        </p:nvGrpSpPr>
        <p:grpSpPr>
          <a:xfrm>
            <a:off x="5597925" y="1922479"/>
            <a:ext cx="277000" cy="12693810"/>
            <a:chOff x="458513" y="1922479"/>
            <a:chExt cx="277000" cy="12693810"/>
          </a:xfrm>
        </p:grpSpPr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E823B516-3C77-7EC3-2CE8-CB9155D29D7F}"/>
                </a:ext>
              </a:extLst>
            </p:cNvPr>
            <p:cNvSpPr txBox="1"/>
            <p:nvPr/>
          </p:nvSpPr>
          <p:spPr>
            <a:xfrm rot="16200000">
              <a:off x="161637" y="2219355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51EF26C3-5944-0FD4-093E-129F5F7834BB}"/>
                </a:ext>
              </a:extLst>
            </p:cNvPr>
            <p:cNvSpPr txBox="1"/>
            <p:nvPr/>
          </p:nvSpPr>
          <p:spPr>
            <a:xfrm rot="16200000">
              <a:off x="161637" y="5175120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6C1FB098-1260-CC80-4C08-0C02F4AC5E68}"/>
                </a:ext>
              </a:extLst>
            </p:cNvPr>
            <p:cNvSpPr txBox="1"/>
            <p:nvPr/>
          </p:nvSpPr>
          <p:spPr>
            <a:xfrm rot="16200000">
              <a:off x="161638" y="8130885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51DBB48-487B-8F0D-34BD-A1572F28D9BC}"/>
                </a:ext>
              </a:extLst>
            </p:cNvPr>
            <p:cNvSpPr txBox="1"/>
            <p:nvPr/>
          </p:nvSpPr>
          <p:spPr>
            <a:xfrm rot="16200000">
              <a:off x="161638" y="11086650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E1F06FFB-1ED2-FCA0-25AA-D19E697B2BB9}"/>
                </a:ext>
              </a:extLst>
            </p:cNvPr>
            <p:cNvSpPr txBox="1"/>
            <p:nvPr/>
          </p:nvSpPr>
          <p:spPr>
            <a:xfrm rot="16200000">
              <a:off x="161638" y="14042414"/>
              <a:ext cx="8707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66032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32</TotalTime>
  <Words>122</Words>
  <Application>Microsoft Office PowerPoint</Application>
  <PresentationFormat>ユーザー設定</PresentationFormat>
  <Paragraphs>7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Cambria Math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kamoto ken</dc:creator>
  <cp:lastModifiedBy>sakamoto ken</cp:lastModifiedBy>
  <cp:revision>592</cp:revision>
  <dcterms:created xsi:type="dcterms:W3CDTF">2022-07-19T05:13:05Z</dcterms:created>
  <dcterms:modified xsi:type="dcterms:W3CDTF">2023-04-16T09:17:42Z</dcterms:modified>
</cp:coreProperties>
</file>